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  <p:sldId id="262" r:id="rId5"/>
    <p:sldId id="263" r:id="rId6"/>
    <p:sldId id="264" r:id="rId7"/>
    <p:sldId id="265" r:id="rId8"/>
    <p:sldId id="266" r:id="rId9"/>
    <p:sldId id="267" r:id="rId10"/>
  </p:sldIdLst>
  <p:sldSz cx="9144000" cy="6858000" type="screen4x3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9CDE5"/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119" d="100"/>
          <a:sy n="119" d="100"/>
        </p:scale>
        <p:origin x="-42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0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6" y="366713"/>
            <a:ext cx="4476751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8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3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3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3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1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1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6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5" y="273055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6" y="1435105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5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B2FE2-F864-4303-B1EB-7685F3E87CC4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5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C83711-2ECD-4991-9E31-29155D4BC1D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1A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406577" y="241199"/>
            <a:ext cx="6452198" cy="638610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</a:t>
            </a:r>
            <a:r>
              <a:rPr lang="en-GB" dirty="0" smtClean="0">
                <a:solidFill>
                  <a:srgbClr val="0000FF"/>
                </a:solidFill>
              </a:rPr>
              <a:t>A1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3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248250" y="115026"/>
            <a:ext cx="6593746" cy="6542189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</a:t>
            </a:r>
            <a:r>
              <a:rPr lang="en-GB" dirty="0" smtClean="0">
                <a:solidFill>
                  <a:srgbClr val="0000FF"/>
                </a:solidFill>
              </a:rPr>
              <a:t>A2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2A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13359" y="667207"/>
            <a:ext cx="6900260" cy="606967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A3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4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153695" y="268448"/>
            <a:ext cx="6707724" cy="627496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</a:t>
            </a:r>
            <a:r>
              <a:rPr lang="en-GB" dirty="0" smtClean="0">
                <a:solidFill>
                  <a:srgbClr val="0000FF"/>
                </a:solidFill>
              </a:rPr>
              <a:t>A4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5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812022" y="255468"/>
            <a:ext cx="7098607" cy="643055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A5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icture6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78466" y="301292"/>
            <a:ext cx="7055141" cy="6334399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A6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icture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306974" y="149103"/>
            <a:ext cx="6614946" cy="6420328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A7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8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718410" y="570451"/>
            <a:ext cx="6106807" cy="6128992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925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A8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icture40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357306" y="492085"/>
            <a:ext cx="6509257" cy="615199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0" y="0"/>
            <a:ext cx="12845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>
                <a:solidFill>
                  <a:srgbClr val="0000FF"/>
                </a:solidFill>
              </a:rPr>
              <a:t>Figure S3B1</a:t>
            </a:r>
            <a:endParaRPr lang="en-US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4</TotalTime>
  <Words>18</Words>
  <Application>Microsoft Office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The University of Birmingha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im Williams</dc:creator>
  <cp:lastModifiedBy>Tim Williams</cp:lastModifiedBy>
  <cp:revision>50</cp:revision>
  <dcterms:created xsi:type="dcterms:W3CDTF">2010-09-16T18:41:51Z</dcterms:created>
  <dcterms:modified xsi:type="dcterms:W3CDTF">2011-05-06T14:11:06Z</dcterms:modified>
</cp:coreProperties>
</file>